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notesMasterIdLst>
    <p:notesMasterId r:id="rId3"/>
  </p:notesMasterIdLst>
  <p:sldIdLst>
    <p:sldId id="256" r:id="rId2"/>
  </p:sldIdLst>
  <p:sldSz cx="1079976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63" userDrawn="1">
          <p15:clr>
            <a:srgbClr val="A4A3A4"/>
          </p15:clr>
        </p15:guide>
        <p15:guide id="2" pos="442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438" autoAdjust="0"/>
  </p:normalViewPr>
  <p:slideViewPr>
    <p:cSldViewPr snapToGrid="0" showGuides="1">
      <p:cViewPr>
        <p:scale>
          <a:sx n="40" d="100"/>
          <a:sy n="40" d="100"/>
        </p:scale>
        <p:origin x="1764" y="120"/>
      </p:cViewPr>
      <p:guideLst>
        <p:guide orient="horz" pos="2063"/>
        <p:guide pos="44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581F1D-DB07-46D0-AC63-392E56C173BC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577975" y="1143000"/>
            <a:ext cx="3702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66E76D-4ED2-438F-9D42-2F2C1DB4B5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9744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1pPr>
    <a:lvl2pPr marL="426306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2pPr>
    <a:lvl3pPr marL="852614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3pPr>
    <a:lvl4pPr marL="127892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4pPr>
    <a:lvl5pPr marL="1705227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5pPr>
    <a:lvl6pPr marL="213153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6pPr>
    <a:lvl7pPr marL="2557841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7pPr>
    <a:lvl8pPr marL="2984149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8pPr>
    <a:lvl9pPr marL="341045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472842"/>
            <a:ext cx="9179799" cy="3133172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726842"/>
            <a:ext cx="8099822" cy="2172804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3386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5990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79142"/>
            <a:ext cx="2328699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79142"/>
            <a:ext cx="68511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50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181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243638"/>
            <a:ext cx="9314796" cy="374355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6022610"/>
            <a:ext cx="9314796" cy="1968648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9051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32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79144"/>
            <a:ext cx="9314796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206137"/>
            <a:ext cx="4568805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287331"/>
            <a:ext cx="4568805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206137"/>
            <a:ext cx="4591306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287331"/>
            <a:ext cx="459130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4640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282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84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295769"/>
            <a:ext cx="5467380" cy="639550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438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295769"/>
            <a:ext cx="5467380" cy="639550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722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79144"/>
            <a:ext cx="9314796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395710"/>
            <a:ext cx="9314796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2C8A6-0FA1-4DD5-948A-C066210E261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8341240"/>
            <a:ext cx="364492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01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文本框 139">
            <a:extLst>
              <a:ext uri="{FF2B5EF4-FFF2-40B4-BE49-F238E27FC236}">
                <a16:creationId xmlns:a16="http://schemas.microsoft.com/office/drawing/2014/main" id="{08BDDF77-7C73-4A46-9968-7F14A173EE2F}"/>
              </a:ext>
            </a:extLst>
          </p:cNvPr>
          <p:cNvSpPr txBox="1"/>
          <p:nvPr/>
        </p:nvSpPr>
        <p:spPr>
          <a:xfrm>
            <a:off x="363902" y="5109635"/>
            <a:ext cx="10067626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.Cytokine secretion of UTD cells and FLT3scFv/NKG2D CAR-T after coculture with target cells. </a:t>
            </a:r>
            <a:r>
              <a:rPr lang="en-US" altLang="zh-CN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~B) 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OLM-13 and MV4-11 cells were cultured with or without</a:t>
            </a:r>
            <a:r>
              <a:rPr lang="en-US" altLang="zh-CN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teritinib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for 24h, and then were separately incubated with UTD cells and FLT3scFv/NKG2D CAR-T cells for 24h</a:t>
            </a:r>
            <a:r>
              <a:rPr lang="en-GB" altLang="zh-CN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. The culture supernatants were collected to detect the levels of cytokines-(A) IL-6,(B) GM-CSF. Error bars represent SD of triplicate wells within one run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,</a:t>
            </a:r>
            <a:r>
              <a:rPr lang="en-US" altLang="zh-CN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teritinib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TD,untransfected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T cells.* p&lt;0.05, .* </a:t>
            </a:r>
            <a:r>
              <a:rPr lang="zh-CN" altLang="en-US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&lt;0.01, .*</a:t>
            </a:r>
            <a:r>
              <a:rPr lang="zh-CN" altLang="en-US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 p&lt;0.001, .**** p&lt;0.0001</a:t>
            </a:r>
            <a:endParaRPr lang="zh-CN" altLang="zh-CN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algn="just"/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FE0413A2-729F-48F3-8A73-64A2A5D0653E}"/>
              </a:ext>
            </a:extLst>
          </p:cNvPr>
          <p:cNvSpPr txBox="1"/>
          <p:nvPr/>
        </p:nvSpPr>
        <p:spPr>
          <a:xfrm>
            <a:off x="171527" y="83171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ACC4E328-B0AE-416E-BEA9-0BC94CCD65D7}"/>
              </a:ext>
            </a:extLst>
          </p:cNvPr>
          <p:cNvSpPr txBox="1"/>
          <p:nvPr/>
        </p:nvSpPr>
        <p:spPr>
          <a:xfrm>
            <a:off x="5747283" y="83171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EB3E253-4319-4D0E-9DEC-AAAD05E779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901" y="1170266"/>
            <a:ext cx="4022740" cy="324000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A745BCA6-A957-4B5B-94F2-923909651CE3}"/>
              </a:ext>
            </a:extLst>
          </p:cNvPr>
          <p:cNvSpPr txBox="1"/>
          <p:nvPr/>
        </p:nvSpPr>
        <p:spPr>
          <a:xfrm>
            <a:off x="1214437" y="3944593"/>
            <a:ext cx="10983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OLM-1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3EEFFAC7-2CA1-4BE8-A708-297999B462B7}"/>
              </a:ext>
            </a:extLst>
          </p:cNvPr>
          <p:cNvSpPr txBox="1"/>
          <p:nvPr/>
        </p:nvSpPr>
        <p:spPr>
          <a:xfrm>
            <a:off x="2571389" y="3944593"/>
            <a:ext cx="8875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V4-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D3D0886-A66A-462A-9D27-86C2DFD3CE82}"/>
              </a:ext>
            </a:extLst>
          </p:cNvPr>
          <p:cNvSpPr txBox="1"/>
          <p:nvPr/>
        </p:nvSpPr>
        <p:spPr>
          <a:xfrm>
            <a:off x="648256" y="133299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F90A1A1A-8758-44CB-9118-0FDDBCC85C0A}"/>
              </a:ext>
            </a:extLst>
          </p:cNvPr>
          <p:cNvSpPr txBox="1"/>
          <p:nvPr/>
        </p:nvSpPr>
        <p:spPr>
          <a:xfrm>
            <a:off x="648256" y="211404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8A83880-9D3F-4666-AE08-8504B31A1DE7}"/>
              </a:ext>
            </a:extLst>
          </p:cNvPr>
          <p:cNvSpPr txBox="1"/>
          <p:nvPr/>
        </p:nvSpPr>
        <p:spPr>
          <a:xfrm>
            <a:off x="648256" y="282587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01F28706-BD4B-44C3-806B-A9C16955BAD6}"/>
              </a:ext>
            </a:extLst>
          </p:cNvPr>
          <p:cNvSpPr txBox="1"/>
          <p:nvPr/>
        </p:nvSpPr>
        <p:spPr>
          <a:xfrm>
            <a:off x="762068" y="369957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29834005-5C7B-4474-BB0A-F2C84F09C5CC}"/>
              </a:ext>
            </a:extLst>
          </p:cNvPr>
          <p:cNvCxnSpPr/>
          <p:nvPr/>
        </p:nvCxnSpPr>
        <p:spPr>
          <a:xfrm>
            <a:off x="1357313" y="2028317"/>
            <a:ext cx="40631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5F23ADF3-4F8C-4576-B2CD-F0374330BB50}"/>
              </a:ext>
            </a:extLst>
          </p:cNvPr>
          <p:cNvCxnSpPr/>
          <p:nvPr/>
        </p:nvCxnSpPr>
        <p:spPr>
          <a:xfrm>
            <a:off x="1666881" y="1652077"/>
            <a:ext cx="40631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6C159F5F-B7AC-49C3-9036-66AD13942D39}"/>
              </a:ext>
            </a:extLst>
          </p:cNvPr>
          <p:cNvCxnSpPr/>
          <p:nvPr/>
        </p:nvCxnSpPr>
        <p:spPr>
          <a:xfrm>
            <a:off x="2524134" y="2094989"/>
            <a:ext cx="40631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D5330026-2B3B-4FBC-82A9-9B9239876691}"/>
              </a:ext>
            </a:extLst>
          </p:cNvPr>
          <p:cNvCxnSpPr/>
          <p:nvPr/>
        </p:nvCxnSpPr>
        <p:spPr>
          <a:xfrm>
            <a:off x="2833702" y="1718749"/>
            <a:ext cx="40631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8B50258E-83CB-4D68-B599-98B08D83C792}"/>
              </a:ext>
            </a:extLst>
          </p:cNvPr>
          <p:cNvSpPr txBox="1"/>
          <p:nvPr/>
        </p:nvSpPr>
        <p:spPr>
          <a:xfrm>
            <a:off x="1399616" y="1730704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E9E64F04-7AC3-40F4-A397-6C09ED9FC497}"/>
              </a:ext>
            </a:extLst>
          </p:cNvPr>
          <p:cNvSpPr txBox="1"/>
          <p:nvPr/>
        </p:nvSpPr>
        <p:spPr>
          <a:xfrm>
            <a:off x="2472819" y="1808873"/>
            <a:ext cx="5052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2C6CA40A-7A36-49F4-AB0D-B348FC308D0C}"/>
              </a:ext>
            </a:extLst>
          </p:cNvPr>
          <p:cNvSpPr txBox="1"/>
          <p:nvPr/>
        </p:nvSpPr>
        <p:spPr>
          <a:xfrm>
            <a:off x="2784224" y="1417882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78C69E94-970E-4A87-A1AA-E2D5146FC942}"/>
              </a:ext>
            </a:extLst>
          </p:cNvPr>
          <p:cNvSpPr txBox="1"/>
          <p:nvPr/>
        </p:nvSpPr>
        <p:spPr>
          <a:xfrm>
            <a:off x="1699118" y="1276265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C6F863B-B04F-40D4-97E4-2D435A33D9EC}"/>
              </a:ext>
            </a:extLst>
          </p:cNvPr>
          <p:cNvSpPr txBox="1"/>
          <p:nvPr/>
        </p:nvSpPr>
        <p:spPr>
          <a:xfrm>
            <a:off x="4285224" y="1482800"/>
            <a:ext cx="8583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F897E186-C491-4080-8AEF-D59C0F6A0821}"/>
              </a:ext>
            </a:extLst>
          </p:cNvPr>
          <p:cNvSpPr txBox="1"/>
          <p:nvPr/>
        </p:nvSpPr>
        <p:spPr>
          <a:xfrm>
            <a:off x="4282214" y="1821354"/>
            <a:ext cx="8583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AFE373E-92FE-43D6-AE43-BA3AC6487CEA}"/>
              </a:ext>
            </a:extLst>
          </p:cNvPr>
          <p:cNvSpPr txBox="1"/>
          <p:nvPr/>
        </p:nvSpPr>
        <p:spPr>
          <a:xfrm>
            <a:off x="4297656" y="2147427"/>
            <a:ext cx="1104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A174371-A47A-4455-9AC4-CA54F8CE8ABA}"/>
              </a:ext>
            </a:extLst>
          </p:cNvPr>
          <p:cNvSpPr txBox="1"/>
          <p:nvPr/>
        </p:nvSpPr>
        <p:spPr>
          <a:xfrm rot="10800000">
            <a:off x="271284" y="2040404"/>
            <a:ext cx="430887" cy="114390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IL-6 (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1B399E01-1890-4621-A192-B1A7F540F13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2555" y="1170265"/>
            <a:ext cx="3735140" cy="2906305"/>
          </a:xfrm>
          <a:prstGeom prst="rect">
            <a:avLst/>
          </a:prstGeom>
        </p:spPr>
      </p:pic>
      <p:sp>
        <p:nvSpPr>
          <p:cNvPr id="77" name="文本框 76">
            <a:extLst>
              <a:ext uri="{FF2B5EF4-FFF2-40B4-BE49-F238E27FC236}">
                <a16:creationId xmlns:a16="http://schemas.microsoft.com/office/drawing/2014/main" id="{EB73D034-09FE-4E58-9C83-286812BD9F35}"/>
              </a:ext>
            </a:extLst>
          </p:cNvPr>
          <p:cNvSpPr txBox="1"/>
          <p:nvPr/>
        </p:nvSpPr>
        <p:spPr>
          <a:xfrm>
            <a:off x="6624650" y="3911249"/>
            <a:ext cx="10983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OLM-1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6064AA9-FB92-4F2D-8E3C-57EECD414C51}"/>
              </a:ext>
            </a:extLst>
          </p:cNvPr>
          <p:cNvSpPr txBox="1"/>
          <p:nvPr/>
        </p:nvSpPr>
        <p:spPr>
          <a:xfrm>
            <a:off x="7981602" y="3911249"/>
            <a:ext cx="8875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V4-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C56625BC-7287-4EAE-95D6-28FFEEB68857}"/>
              </a:ext>
            </a:extLst>
          </p:cNvPr>
          <p:cNvSpPr txBox="1"/>
          <p:nvPr/>
        </p:nvSpPr>
        <p:spPr>
          <a:xfrm>
            <a:off x="6058469" y="129965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D0758009-3C04-448B-8236-B612A6B32023}"/>
              </a:ext>
            </a:extLst>
          </p:cNvPr>
          <p:cNvSpPr txBox="1"/>
          <p:nvPr/>
        </p:nvSpPr>
        <p:spPr>
          <a:xfrm>
            <a:off x="6058469" y="208070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1FD8EDD5-6A5F-4D8D-B6D0-FC48766A7C7C}"/>
              </a:ext>
            </a:extLst>
          </p:cNvPr>
          <p:cNvSpPr txBox="1"/>
          <p:nvPr/>
        </p:nvSpPr>
        <p:spPr>
          <a:xfrm>
            <a:off x="6058469" y="279253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F0C3D281-14FE-4300-ADB7-642189414828}"/>
              </a:ext>
            </a:extLst>
          </p:cNvPr>
          <p:cNvSpPr txBox="1"/>
          <p:nvPr/>
        </p:nvSpPr>
        <p:spPr>
          <a:xfrm>
            <a:off x="6172281" y="366623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058FDB23-449B-4BE4-9420-363C4C2A2AB8}"/>
              </a:ext>
            </a:extLst>
          </p:cNvPr>
          <p:cNvCxnSpPr/>
          <p:nvPr/>
        </p:nvCxnSpPr>
        <p:spPr>
          <a:xfrm>
            <a:off x="6724662" y="1523481"/>
            <a:ext cx="40631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FC15D91E-3398-4D84-85B8-AFD28B3878B3}"/>
              </a:ext>
            </a:extLst>
          </p:cNvPr>
          <p:cNvCxnSpPr/>
          <p:nvPr/>
        </p:nvCxnSpPr>
        <p:spPr>
          <a:xfrm>
            <a:off x="7034230" y="1147241"/>
            <a:ext cx="40631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3A2080C7-CC39-4E58-BEC5-E658023B2F6D}"/>
              </a:ext>
            </a:extLst>
          </p:cNvPr>
          <p:cNvCxnSpPr/>
          <p:nvPr/>
        </p:nvCxnSpPr>
        <p:spPr>
          <a:xfrm>
            <a:off x="7891483" y="1590153"/>
            <a:ext cx="40631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2FE3D26F-C81F-4460-AE66-5F0079903449}"/>
              </a:ext>
            </a:extLst>
          </p:cNvPr>
          <p:cNvCxnSpPr/>
          <p:nvPr/>
        </p:nvCxnSpPr>
        <p:spPr>
          <a:xfrm>
            <a:off x="8201051" y="1213913"/>
            <a:ext cx="406313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CA5C3462-0D91-4F42-A66C-074BA8FBAF28}"/>
              </a:ext>
            </a:extLst>
          </p:cNvPr>
          <p:cNvSpPr txBox="1"/>
          <p:nvPr/>
        </p:nvSpPr>
        <p:spPr>
          <a:xfrm>
            <a:off x="6809829" y="1225868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10105F0C-8915-4C1E-8C8D-E8C30EF1CC73}"/>
              </a:ext>
            </a:extLst>
          </p:cNvPr>
          <p:cNvSpPr txBox="1"/>
          <p:nvPr/>
        </p:nvSpPr>
        <p:spPr>
          <a:xfrm>
            <a:off x="7882715" y="1332995"/>
            <a:ext cx="4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4E79C9E5-FE32-4D2F-9B2A-36F4AB6B2042}"/>
              </a:ext>
            </a:extLst>
          </p:cNvPr>
          <p:cNvSpPr txBox="1"/>
          <p:nvPr/>
        </p:nvSpPr>
        <p:spPr>
          <a:xfrm>
            <a:off x="8151573" y="913046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355636EC-2B06-4F84-B5AE-FD1D86DA43AB}"/>
              </a:ext>
            </a:extLst>
          </p:cNvPr>
          <p:cNvSpPr txBox="1"/>
          <p:nvPr/>
        </p:nvSpPr>
        <p:spPr>
          <a:xfrm>
            <a:off x="7066467" y="771429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760FB1C3-85C7-48CD-86A3-41B24A127017}"/>
              </a:ext>
            </a:extLst>
          </p:cNvPr>
          <p:cNvSpPr txBox="1"/>
          <p:nvPr/>
        </p:nvSpPr>
        <p:spPr>
          <a:xfrm>
            <a:off x="9695437" y="1449456"/>
            <a:ext cx="8583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79853845-12CB-465F-AB89-BD60CEC7FE5D}"/>
              </a:ext>
            </a:extLst>
          </p:cNvPr>
          <p:cNvSpPr txBox="1"/>
          <p:nvPr/>
        </p:nvSpPr>
        <p:spPr>
          <a:xfrm>
            <a:off x="9692427" y="1788010"/>
            <a:ext cx="8583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502150A2-9BA4-4E27-A302-B342B132802E}"/>
              </a:ext>
            </a:extLst>
          </p:cNvPr>
          <p:cNvSpPr txBox="1"/>
          <p:nvPr/>
        </p:nvSpPr>
        <p:spPr>
          <a:xfrm>
            <a:off x="9707869" y="2114083"/>
            <a:ext cx="11043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AAE78B0B-993B-403F-9554-DC4502FB5048}"/>
              </a:ext>
            </a:extLst>
          </p:cNvPr>
          <p:cNvSpPr txBox="1"/>
          <p:nvPr/>
        </p:nvSpPr>
        <p:spPr>
          <a:xfrm rot="10800000">
            <a:off x="5681497" y="1779434"/>
            <a:ext cx="430887" cy="159915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M-CSF (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0178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0</TotalTime>
  <Words>161</Words>
  <Application>Microsoft Office PowerPoint</Application>
  <PresentationFormat>自定义</PresentationFormat>
  <Paragraphs>3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011747492@qq.com</dc:creator>
  <cp:lastModifiedBy>1011747492@qq.com</cp:lastModifiedBy>
  <cp:revision>13</cp:revision>
  <dcterms:created xsi:type="dcterms:W3CDTF">2021-09-27T10:15:49Z</dcterms:created>
  <dcterms:modified xsi:type="dcterms:W3CDTF">2022-01-26T09:58:32Z</dcterms:modified>
</cp:coreProperties>
</file>